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1396" r:id="rId2"/>
  </p:sldIdLst>
  <p:sldSz cx="12192000" cy="6858000"/>
  <p:notesSz cx="6797675" cy="99266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59" d="100"/>
          <a:sy n="59" d="100"/>
        </p:scale>
        <p:origin x="868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eda\Desktop\2019&#24180;&#12461;&#12515;&#12531;&#12487;&#12451;&#12531;&#30740;&#31350;&#20250;%20VRCZ&#22810;&#26045;&#35373;\VRCZ&#12398;&#12487;&#12540;&#12479;\&#12461;&#12515;&#12531;&#12487;&#12451;&#12531;%202019%20&#12487;&#12540;&#12479;&#32113;&#21512;%20&#27835;&#39443;&#38500;&#22806;%2020200119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202966658492714"/>
          <c:y val="4.3172752154670396E-2"/>
          <c:w val="0.84797033341507289"/>
          <c:h val="0.83626640267101482"/>
        </c:manualLayout>
      </c:layout>
      <c:lineChart>
        <c:grouping val="standard"/>
        <c:varyColors val="0"/>
        <c:ser>
          <c:idx val="0"/>
          <c:order val="0"/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strRef>
              <c:f>'治療 注射→経口(n=26)'!$O$1:$P$1</c:f>
              <c:strCache>
                <c:ptCount val="2"/>
                <c:pt idx="0">
                  <c:v>Intravenous administration</c:v>
                </c:pt>
                <c:pt idx="1">
                  <c:v>Oral administration</c:v>
                </c:pt>
              </c:strCache>
            </c:strRef>
          </c:cat>
          <c:val>
            <c:numRef>
              <c:f>'治療 注射→経口(n=26)'!$O$2:$P$2</c:f>
              <c:numCache>
                <c:formatCode>0.00_);[Red]\(0.00\)</c:formatCode>
                <c:ptCount val="2"/>
                <c:pt idx="0">
                  <c:v>2.09</c:v>
                </c:pt>
                <c:pt idx="1">
                  <c:v>1.715000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0918-4591-9FDE-5246CA383EA4}"/>
            </c:ext>
          </c:extLst>
        </c:ser>
        <c:ser>
          <c:idx val="1"/>
          <c:order val="1"/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strRef>
              <c:f>'治療 注射→経口(n=26)'!$O$1:$P$1</c:f>
              <c:strCache>
                <c:ptCount val="2"/>
                <c:pt idx="0">
                  <c:v>Intravenous administration</c:v>
                </c:pt>
                <c:pt idx="1">
                  <c:v>Oral administration</c:v>
                </c:pt>
              </c:strCache>
            </c:strRef>
          </c:cat>
          <c:val>
            <c:numRef>
              <c:f>'治療 注射→経口(n=26)'!$O$3:$P$3</c:f>
              <c:numCache>
                <c:formatCode>0.00_);[Red]\(0.00\)</c:formatCode>
                <c:ptCount val="2"/>
                <c:pt idx="0">
                  <c:v>3.02</c:v>
                </c:pt>
                <c:pt idx="1">
                  <c:v>2.5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0918-4591-9FDE-5246CA383EA4}"/>
            </c:ext>
          </c:extLst>
        </c:ser>
        <c:ser>
          <c:idx val="2"/>
          <c:order val="2"/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strRef>
              <c:f>'治療 注射→経口(n=26)'!$O$1:$P$1</c:f>
              <c:strCache>
                <c:ptCount val="2"/>
                <c:pt idx="0">
                  <c:v>Intravenous administration</c:v>
                </c:pt>
                <c:pt idx="1">
                  <c:v>Oral administration</c:v>
                </c:pt>
              </c:strCache>
            </c:strRef>
          </c:cat>
          <c:val>
            <c:numRef>
              <c:f>'治療 注射→経口(n=26)'!$O$4:$P$4</c:f>
              <c:numCache>
                <c:formatCode>0.00_);[Red]\(0.00\)</c:formatCode>
                <c:ptCount val="2"/>
                <c:pt idx="0">
                  <c:v>3.17</c:v>
                </c:pt>
                <c:pt idx="1">
                  <c:v>2.8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0918-4591-9FDE-5246CA383EA4}"/>
            </c:ext>
          </c:extLst>
        </c:ser>
        <c:ser>
          <c:idx val="3"/>
          <c:order val="3"/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strRef>
              <c:f>'治療 注射→経口(n=26)'!$O$1:$P$1</c:f>
              <c:strCache>
                <c:ptCount val="2"/>
                <c:pt idx="0">
                  <c:v>Intravenous administration</c:v>
                </c:pt>
                <c:pt idx="1">
                  <c:v>Oral administration</c:v>
                </c:pt>
              </c:strCache>
            </c:strRef>
          </c:cat>
          <c:val>
            <c:numRef>
              <c:f>'治療 注射→経口(n=26)'!$O$5:$P$5</c:f>
              <c:numCache>
                <c:formatCode>0.00_);[Red]\(0.00\)</c:formatCode>
                <c:ptCount val="2"/>
                <c:pt idx="0">
                  <c:v>3.09</c:v>
                </c:pt>
                <c:pt idx="1">
                  <c:v>1.3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0918-4591-9FDE-5246CA383EA4}"/>
            </c:ext>
          </c:extLst>
        </c:ser>
        <c:ser>
          <c:idx val="4"/>
          <c:order val="4"/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strRef>
              <c:f>'治療 注射→経口(n=26)'!$O$1:$P$1</c:f>
              <c:strCache>
                <c:ptCount val="2"/>
                <c:pt idx="0">
                  <c:v>Intravenous administration</c:v>
                </c:pt>
                <c:pt idx="1">
                  <c:v>Oral administration</c:v>
                </c:pt>
              </c:strCache>
            </c:strRef>
          </c:cat>
          <c:val>
            <c:numRef>
              <c:f>'治療 注射→経口(n=26)'!$O$6:$P$6</c:f>
              <c:numCache>
                <c:formatCode>0.00_);[Red]\(0.00\)</c:formatCode>
                <c:ptCount val="2"/>
                <c:pt idx="0">
                  <c:v>2.5499999999999998</c:v>
                </c:pt>
                <c:pt idx="1">
                  <c:v>2.00999999999999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0918-4591-9FDE-5246CA383EA4}"/>
            </c:ext>
          </c:extLst>
        </c:ser>
        <c:ser>
          <c:idx val="5"/>
          <c:order val="5"/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strRef>
              <c:f>'治療 注射→経口(n=26)'!$O$1:$P$1</c:f>
              <c:strCache>
                <c:ptCount val="2"/>
                <c:pt idx="0">
                  <c:v>Intravenous administration</c:v>
                </c:pt>
                <c:pt idx="1">
                  <c:v>Oral administration</c:v>
                </c:pt>
              </c:strCache>
            </c:strRef>
          </c:cat>
          <c:val>
            <c:numRef>
              <c:f>'治療 注射→経口(n=26)'!$O$7:$P$7</c:f>
              <c:numCache>
                <c:formatCode>0.00_);[Red]\(0.00\)</c:formatCode>
                <c:ptCount val="2"/>
                <c:pt idx="0">
                  <c:v>3.43</c:v>
                </c:pt>
                <c:pt idx="1">
                  <c:v>2.54999999999999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0918-4591-9FDE-5246CA383EA4}"/>
            </c:ext>
          </c:extLst>
        </c:ser>
        <c:ser>
          <c:idx val="6"/>
          <c:order val="6"/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strRef>
              <c:f>'治療 注射→経口(n=26)'!$O$1:$P$1</c:f>
              <c:strCache>
                <c:ptCount val="2"/>
                <c:pt idx="0">
                  <c:v>Intravenous administration</c:v>
                </c:pt>
                <c:pt idx="1">
                  <c:v>Oral administration</c:v>
                </c:pt>
              </c:strCache>
            </c:strRef>
          </c:cat>
          <c:val>
            <c:numRef>
              <c:f>'治療 注射→経口(n=26)'!$O$8:$P$8</c:f>
              <c:numCache>
                <c:formatCode>General</c:formatCode>
                <c:ptCount val="2"/>
                <c:pt idx="0" formatCode="0.00_);[Red]\(0.00\)">
                  <c:v>3.8299999999999996</c:v>
                </c:pt>
                <c:pt idx="1">
                  <c:v>2.3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0918-4591-9FDE-5246CA383EA4}"/>
            </c:ext>
          </c:extLst>
        </c:ser>
        <c:ser>
          <c:idx val="7"/>
          <c:order val="7"/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strRef>
              <c:f>'治療 注射→経口(n=26)'!$O$1:$P$1</c:f>
              <c:strCache>
                <c:ptCount val="2"/>
                <c:pt idx="0">
                  <c:v>Intravenous administration</c:v>
                </c:pt>
                <c:pt idx="1">
                  <c:v>Oral administration</c:v>
                </c:pt>
              </c:strCache>
            </c:strRef>
          </c:cat>
          <c:val>
            <c:numRef>
              <c:f>'治療 注射→経口(n=26)'!$O$9:$P$9</c:f>
              <c:numCache>
                <c:formatCode>0.00_);[Red]\(0.00\)</c:formatCode>
                <c:ptCount val="2"/>
                <c:pt idx="0">
                  <c:v>3.31</c:v>
                </c:pt>
                <c:pt idx="1">
                  <c:v>2.9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7-0918-4591-9FDE-5246CA383EA4}"/>
            </c:ext>
          </c:extLst>
        </c:ser>
        <c:ser>
          <c:idx val="8"/>
          <c:order val="8"/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strRef>
              <c:f>'治療 注射→経口(n=26)'!$O$1:$P$1</c:f>
              <c:strCache>
                <c:ptCount val="2"/>
                <c:pt idx="0">
                  <c:v>Intravenous administration</c:v>
                </c:pt>
                <c:pt idx="1">
                  <c:v>Oral administration</c:v>
                </c:pt>
              </c:strCache>
            </c:strRef>
          </c:cat>
          <c:val>
            <c:numRef>
              <c:f>'治療 注射→経口(n=26)'!$O$10:$P$10</c:f>
              <c:numCache>
                <c:formatCode>0.00_);[Red]\(0.00\)</c:formatCode>
                <c:ptCount val="2"/>
                <c:pt idx="0">
                  <c:v>2.52</c:v>
                </c:pt>
                <c:pt idx="1">
                  <c:v>2.1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8-0918-4591-9FDE-5246CA383EA4}"/>
            </c:ext>
          </c:extLst>
        </c:ser>
        <c:ser>
          <c:idx val="9"/>
          <c:order val="9"/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strRef>
              <c:f>'治療 注射→経口(n=26)'!$O$1:$P$1</c:f>
              <c:strCache>
                <c:ptCount val="2"/>
                <c:pt idx="0">
                  <c:v>Intravenous administration</c:v>
                </c:pt>
                <c:pt idx="1">
                  <c:v>Oral administration</c:v>
                </c:pt>
              </c:strCache>
            </c:strRef>
          </c:cat>
          <c:val>
            <c:numRef>
              <c:f>'治療 注射→経口(n=26)'!$O$11:$P$11</c:f>
              <c:numCache>
                <c:formatCode>0.00_);[Red]\(0.00\)</c:formatCode>
                <c:ptCount val="2"/>
                <c:pt idx="0">
                  <c:v>3.1</c:v>
                </c:pt>
                <c:pt idx="1">
                  <c:v>2.8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9-0918-4591-9FDE-5246CA383EA4}"/>
            </c:ext>
          </c:extLst>
        </c:ser>
        <c:ser>
          <c:idx val="10"/>
          <c:order val="10"/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strRef>
              <c:f>'治療 注射→経口(n=26)'!$O$1:$P$1</c:f>
              <c:strCache>
                <c:ptCount val="2"/>
                <c:pt idx="0">
                  <c:v>Intravenous administration</c:v>
                </c:pt>
                <c:pt idx="1">
                  <c:v>Oral administration</c:v>
                </c:pt>
              </c:strCache>
            </c:strRef>
          </c:cat>
          <c:val>
            <c:numRef>
              <c:f>'治療 注射→経口(n=26)'!$O$12:$P$12</c:f>
              <c:numCache>
                <c:formatCode>0.00_);[Red]\(0.00\)</c:formatCode>
                <c:ptCount val="2"/>
                <c:pt idx="0">
                  <c:v>3.06</c:v>
                </c:pt>
                <c:pt idx="1">
                  <c:v>2.2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A-0918-4591-9FDE-5246CA383EA4}"/>
            </c:ext>
          </c:extLst>
        </c:ser>
        <c:ser>
          <c:idx val="11"/>
          <c:order val="11"/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strRef>
              <c:f>'治療 注射→経口(n=26)'!$O$1:$P$1</c:f>
              <c:strCache>
                <c:ptCount val="2"/>
                <c:pt idx="0">
                  <c:v>Intravenous administration</c:v>
                </c:pt>
                <c:pt idx="1">
                  <c:v>Oral administration</c:v>
                </c:pt>
              </c:strCache>
            </c:strRef>
          </c:cat>
          <c:val>
            <c:numRef>
              <c:f>'治療 注射→経口(n=26)'!$O$13:$P$13</c:f>
              <c:numCache>
                <c:formatCode>0.00_);[Red]\(0.00\)</c:formatCode>
                <c:ptCount val="2"/>
                <c:pt idx="0">
                  <c:v>2.61</c:v>
                </c:pt>
                <c:pt idx="1">
                  <c:v>1.8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B-0918-4591-9FDE-5246CA383EA4}"/>
            </c:ext>
          </c:extLst>
        </c:ser>
        <c:ser>
          <c:idx val="12"/>
          <c:order val="12"/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strRef>
              <c:f>'治療 注射→経口(n=26)'!$O$1:$P$1</c:f>
              <c:strCache>
                <c:ptCount val="2"/>
                <c:pt idx="0">
                  <c:v>Intravenous administration</c:v>
                </c:pt>
                <c:pt idx="1">
                  <c:v>Oral administration</c:v>
                </c:pt>
              </c:strCache>
            </c:strRef>
          </c:cat>
          <c:val>
            <c:numRef>
              <c:f>'治療 注射→経口(n=26)'!$O$14:$P$14</c:f>
              <c:numCache>
                <c:formatCode>0.00_);[Red]\(0.00\)</c:formatCode>
                <c:ptCount val="2"/>
                <c:pt idx="0">
                  <c:v>2.48</c:v>
                </c:pt>
                <c:pt idx="1">
                  <c:v>1.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C-0918-4591-9FDE-5246CA383EA4}"/>
            </c:ext>
          </c:extLst>
        </c:ser>
        <c:ser>
          <c:idx val="13"/>
          <c:order val="13"/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strRef>
              <c:f>'治療 注射→経口(n=26)'!$O$1:$P$1</c:f>
              <c:strCache>
                <c:ptCount val="2"/>
                <c:pt idx="0">
                  <c:v>Intravenous administration</c:v>
                </c:pt>
                <c:pt idx="1">
                  <c:v>Oral administration</c:v>
                </c:pt>
              </c:strCache>
            </c:strRef>
          </c:cat>
          <c:val>
            <c:numRef>
              <c:f>'治療 注射→経口(n=26)'!$O$15:$P$15</c:f>
              <c:numCache>
                <c:formatCode>0.00_);[Red]\(0.00\)</c:formatCode>
                <c:ptCount val="2"/>
                <c:pt idx="0">
                  <c:v>3.66</c:v>
                </c:pt>
                <c:pt idx="1">
                  <c:v>2.5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D-0918-4591-9FDE-5246CA383EA4}"/>
            </c:ext>
          </c:extLst>
        </c:ser>
        <c:ser>
          <c:idx val="14"/>
          <c:order val="14"/>
          <c:spPr>
            <a:ln w="19050" cap="rnd">
              <a:solidFill>
                <a:schemeClr val="accent3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dPt>
            <c:idx val="1"/>
            <c:marker>
              <c:symbol val="none"/>
            </c:marker>
            <c:bubble3D val="0"/>
            <c:spPr>
              <a:ln w="19050" cap="rnd">
                <a:solidFill>
                  <a:schemeClr val="tx1"/>
                </a:solidFill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0-9BCC-4F15-BCEB-3909F49A5B46}"/>
              </c:ext>
            </c:extLst>
          </c:dPt>
          <c:cat>
            <c:strRef>
              <c:f>'治療 注射→経口(n=26)'!$O$1:$P$1</c:f>
              <c:strCache>
                <c:ptCount val="2"/>
                <c:pt idx="0">
                  <c:v>Intravenous administration</c:v>
                </c:pt>
                <c:pt idx="1">
                  <c:v>Oral administration</c:v>
                </c:pt>
              </c:strCache>
            </c:strRef>
          </c:cat>
          <c:val>
            <c:numRef>
              <c:f>'治療 注射→経口(n=26)'!$O$16:$P$16</c:f>
              <c:numCache>
                <c:formatCode>0.00_);[Red]\(0.00\)</c:formatCode>
                <c:ptCount val="2"/>
                <c:pt idx="0" formatCode="General">
                  <c:v>4.33</c:v>
                </c:pt>
                <c:pt idx="1">
                  <c:v>3.8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E-0918-4591-9FDE-5246CA383EA4}"/>
            </c:ext>
          </c:extLst>
        </c:ser>
        <c:ser>
          <c:idx val="15"/>
          <c:order val="15"/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strRef>
              <c:f>'治療 注射→経口(n=26)'!$O$1:$P$1</c:f>
              <c:strCache>
                <c:ptCount val="2"/>
                <c:pt idx="0">
                  <c:v>Intravenous administration</c:v>
                </c:pt>
                <c:pt idx="1">
                  <c:v>Oral administration</c:v>
                </c:pt>
              </c:strCache>
            </c:strRef>
          </c:cat>
          <c:val>
            <c:numRef>
              <c:f>'治療 注射→経口(n=26)'!$O$17:$P$17</c:f>
              <c:numCache>
                <c:formatCode>0.00_);[Red]\(0.00\)</c:formatCode>
                <c:ptCount val="2"/>
                <c:pt idx="0">
                  <c:v>1.56</c:v>
                </c:pt>
                <c:pt idx="1">
                  <c:v>1.0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F-0918-4591-9FDE-5246CA383EA4}"/>
            </c:ext>
          </c:extLst>
        </c:ser>
        <c:ser>
          <c:idx val="16"/>
          <c:order val="16"/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strRef>
              <c:f>'治療 注射→経口(n=26)'!$O$1:$P$1</c:f>
              <c:strCache>
                <c:ptCount val="2"/>
                <c:pt idx="0">
                  <c:v>Intravenous administration</c:v>
                </c:pt>
                <c:pt idx="1">
                  <c:v>Oral administration</c:v>
                </c:pt>
              </c:strCache>
            </c:strRef>
          </c:cat>
          <c:val>
            <c:numRef>
              <c:f>'治療 注射→経口(n=26)'!$O$18:$P$18</c:f>
              <c:numCache>
                <c:formatCode>0.00_);[Red]\(0.00\)</c:formatCode>
                <c:ptCount val="2"/>
                <c:pt idx="0">
                  <c:v>2.48</c:v>
                </c:pt>
                <c:pt idx="1">
                  <c:v>2.3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0-0918-4591-9FDE-5246CA383EA4}"/>
            </c:ext>
          </c:extLst>
        </c:ser>
        <c:ser>
          <c:idx val="17"/>
          <c:order val="17"/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strRef>
              <c:f>'治療 注射→経口(n=26)'!$O$1:$P$1</c:f>
              <c:strCache>
                <c:ptCount val="2"/>
                <c:pt idx="0">
                  <c:v>Intravenous administration</c:v>
                </c:pt>
                <c:pt idx="1">
                  <c:v>Oral administration</c:v>
                </c:pt>
              </c:strCache>
            </c:strRef>
          </c:cat>
          <c:val>
            <c:numRef>
              <c:f>'治療 注射→経口(n=26)'!$O$19:$P$19</c:f>
              <c:numCache>
                <c:formatCode>0.00_);[Red]\(0.00\)</c:formatCode>
                <c:ptCount val="2"/>
                <c:pt idx="0">
                  <c:v>1.08</c:v>
                </c:pt>
                <c:pt idx="1">
                  <c:v>1.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1-0918-4591-9FDE-5246CA383EA4}"/>
            </c:ext>
          </c:extLst>
        </c:ser>
        <c:ser>
          <c:idx val="18"/>
          <c:order val="18"/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strRef>
              <c:f>'治療 注射→経口(n=26)'!$O$1:$P$1</c:f>
              <c:strCache>
                <c:ptCount val="2"/>
                <c:pt idx="0">
                  <c:v>Intravenous administration</c:v>
                </c:pt>
                <c:pt idx="1">
                  <c:v>Oral administration</c:v>
                </c:pt>
              </c:strCache>
            </c:strRef>
          </c:cat>
          <c:val>
            <c:numRef>
              <c:f>'治療 注射→経口(n=26)'!$O$20:$P$20</c:f>
              <c:numCache>
                <c:formatCode>0.00_);[Red]\(0.00\)</c:formatCode>
                <c:ptCount val="2"/>
                <c:pt idx="0">
                  <c:v>1.33</c:v>
                </c:pt>
                <c:pt idx="1">
                  <c:v>1.4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2-0918-4591-9FDE-5246CA383EA4}"/>
            </c:ext>
          </c:extLst>
        </c:ser>
        <c:ser>
          <c:idx val="19"/>
          <c:order val="19"/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strRef>
              <c:f>'治療 注射→経口(n=26)'!$O$1:$P$1</c:f>
              <c:strCache>
                <c:ptCount val="2"/>
                <c:pt idx="0">
                  <c:v>Intravenous administration</c:v>
                </c:pt>
                <c:pt idx="1">
                  <c:v>Oral administration</c:v>
                </c:pt>
              </c:strCache>
            </c:strRef>
          </c:cat>
          <c:val>
            <c:numRef>
              <c:f>'治療 注射→経口(n=26)'!$O$21:$P$21</c:f>
              <c:numCache>
                <c:formatCode>0.00_);[Red]\(0.00\)</c:formatCode>
                <c:ptCount val="2"/>
                <c:pt idx="0">
                  <c:v>1.7</c:v>
                </c:pt>
                <c:pt idx="1">
                  <c:v>1.4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3-0918-4591-9FDE-5246CA383EA4}"/>
            </c:ext>
          </c:extLst>
        </c:ser>
        <c:ser>
          <c:idx val="20"/>
          <c:order val="20"/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strRef>
              <c:f>'治療 注射→経口(n=26)'!$O$1:$P$1</c:f>
              <c:strCache>
                <c:ptCount val="2"/>
                <c:pt idx="0">
                  <c:v>Intravenous administration</c:v>
                </c:pt>
                <c:pt idx="1">
                  <c:v>Oral administration</c:v>
                </c:pt>
              </c:strCache>
            </c:strRef>
          </c:cat>
          <c:val>
            <c:numRef>
              <c:f>'治療 注射→経口(n=26)'!$O$22:$P$22</c:f>
              <c:numCache>
                <c:formatCode>0.00_);[Red]\(0.00\)</c:formatCode>
                <c:ptCount val="2"/>
                <c:pt idx="0">
                  <c:v>4.4800000000000004</c:v>
                </c:pt>
                <c:pt idx="1">
                  <c:v>3.4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4-0918-4591-9FDE-5246CA383EA4}"/>
            </c:ext>
          </c:extLst>
        </c:ser>
        <c:ser>
          <c:idx val="21"/>
          <c:order val="21"/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strRef>
              <c:f>'治療 注射→経口(n=26)'!$O$1:$P$1</c:f>
              <c:strCache>
                <c:ptCount val="2"/>
                <c:pt idx="0">
                  <c:v>Intravenous administration</c:v>
                </c:pt>
                <c:pt idx="1">
                  <c:v>Oral administration</c:v>
                </c:pt>
              </c:strCache>
            </c:strRef>
          </c:cat>
          <c:val>
            <c:numRef>
              <c:f>'治療 注射→経口(n=26)'!$O$23:$P$23</c:f>
              <c:numCache>
                <c:formatCode>0.00_);[Red]\(0.00\)</c:formatCode>
                <c:ptCount val="2"/>
                <c:pt idx="0">
                  <c:v>0.97</c:v>
                </c:pt>
                <c:pt idx="1">
                  <c:v>0.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5-0918-4591-9FDE-5246CA383EA4}"/>
            </c:ext>
          </c:extLst>
        </c:ser>
        <c:ser>
          <c:idx val="22"/>
          <c:order val="22"/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strRef>
              <c:f>'治療 注射→経口(n=26)'!$O$1:$P$1</c:f>
              <c:strCache>
                <c:ptCount val="2"/>
                <c:pt idx="0">
                  <c:v>Intravenous administration</c:v>
                </c:pt>
                <c:pt idx="1">
                  <c:v>Oral administration</c:v>
                </c:pt>
              </c:strCache>
            </c:strRef>
          </c:cat>
          <c:val>
            <c:numRef>
              <c:f>'治療 注射→経口(n=26)'!$O$24:$P$24</c:f>
              <c:numCache>
                <c:formatCode>0.00_);[Red]\(0.00\)</c:formatCode>
                <c:ptCount val="2"/>
                <c:pt idx="0">
                  <c:v>0.8</c:v>
                </c:pt>
                <c:pt idx="1">
                  <c:v>0.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6-0918-4591-9FDE-5246CA383EA4}"/>
            </c:ext>
          </c:extLst>
        </c:ser>
        <c:ser>
          <c:idx val="23"/>
          <c:order val="23"/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strRef>
              <c:f>'治療 注射→経口(n=26)'!$O$1:$P$1</c:f>
              <c:strCache>
                <c:ptCount val="2"/>
                <c:pt idx="0">
                  <c:v>Intravenous administration</c:v>
                </c:pt>
                <c:pt idx="1">
                  <c:v>Oral administration</c:v>
                </c:pt>
              </c:strCache>
            </c:strRef>
          </c:cat>
          <c:val>
            <c:numRef>
              <c:f>'治療 注射→経口(n=26)'!$O$25:$P$25</c:f>
              <c:numCache>
                <c:formatCode>0.00_);[Red]\(0.00\)</c:formatCode>
                <c:ptCount val="2"/>
                <c:pt idx="0">
                  <c:v>5.03</c:v>
                </c:pt>
                <c:pt idx="1">
                  <c:v>7.5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7-0918-4591-9FDE-5246CA383EA4}"/>
            </c:ext>
          </c:extLst>
        </c:ser>
        <c:ser>
          <c:idx val="24"/>
          <c:order val="24"/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strRef>
              <c:f>'治療 注射→経口(n=26)'!$O$1:$P$1</c:f>
              <c:strCache>
                <c:ptCount val="2"/>
                <c:pt idx="0">
                  <c:v>Intravenous administration</c:v>
                </c:pt>
                <c:pt idx="1">
                  <c:v>Oral administration</c:v>
                </c:pt>
              </c:strCache>
            </c:strRef>
          </c:cat>
          <c:val>
            <c:numRef>
              <c:f>'治療 注射→経口(n=26)'!$O$26:$P$26</c:f>
              <c:numCache>
                <c:formatCode>0.00_);[Red]\(0.00\)</c:formatCode>
                <c:ptCount val="2"/>
                <c:pt idx="0">
                  <c:v>4.3099999999999996</c:v>
                </c:pt>
                <c:pt idx="1">
                  <c:v>3.6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8-0918-4591-9FDE-5246CA383EA4}"/>
            </c:ext>
          </c:extLst>
        </c:ser>
        <c:ser>
          <c:idx val="25"/>
          <c:order val="25"/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strRef>
              <c:f>'治療 注射→経口(n=26)'!$O$1:$P$1</c:f>
              <c:strCache>
                <c:ptCount val="2"/>
                <c:pt idx="0">
                  <c:v>Intravenous administration</c:v>
                </c:pt>
                <c:pt idx="1">
                  <c:v>Oral administration</c:v>
                </c:pt>
              </c:strCache>
            </c:strRef>
          </c:cat>
          <c:val>
            <c:numRef>
              <c:f>'治療 注射→経口(n=26)'!$O$27:$P$27</c:f>
              <c:numCache>
                <c:formatCode>0.00_);[Red]\(0.00\)</c:formatCode>
                <c:ptCount val="2"/>
                <c:pt idx="0">
                  <c:v>2.98</c:v>
                </c:pt>
                <c:pt idx="1">
                  <c:v>2.5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9-0918-4591-9FDE-5246CA383EA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40612736"/>
        <c:axId val="140614272"/>
      </c:lineChart>
      <c:catAx>
        <c:axId val="1406127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40614272"/>
        <c:crosses val="autoZero"/>
        <c:auto val="1"/>
        <c:lblAlgn val="ctr"/>
        <c:lblOffset val="100"/>
        <c:noMultiLvlLbl val="0"/>
      </c:catAx>
      <c:valAx>
        <c:axId val="14061427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14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kumimoji="1" lang="en-US" altLang="ja-JP" sz="1400" b="0" i="0" u="none" strike="noStrike" baseline="0" dirty="0"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Voriconazole C</a:t>
                </a:r>
                <a:r>
                  <a:rPr kumimoji="1" lang="en-US" altLang="ja-JP" sz="1400" b="0" i="0" u="none" strike="noStrike" baseline="-25000" dirty="0"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in </a:t>
                </a:r>
                <a:r>
                  <a:rPr lang="en-US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µg/mL)</a:t>
                </a:r>
                <a:endParaRPr lang="ja-JP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3.8478850739742651E-2"/>
              <c:y val="0.1732280787222885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14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4061273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400"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45659" cy="498056"/>
          </a:xfrm>
          <a:prstGeom prst="rect">
            <a:avLst/>
          </a:prstGeom>
        </p:spPr>
        <p:txBody>
          <a:bodyPr vert="horz" lIns="91426" tIns="45713" rIns="91426" bIns="45713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0444" y="0"/>
            <a:ext cx="2945659" cy="498056"/>
          </a:xfrm>
          <a:prstGeom prst="rect">
            <a:avLst/>
          </a:prstGeom>
        </p:spPr>
        <p:txBody>
          <a:bodyPr vert="horz" lIns="91426" tIns="45713" rIns="91426" bIns="45713" rtlCol="0"/>
          <a:lstStyle>
            <a:lvl1pPr algn="r">
              <a:defRPr sz="1200"/>
            </a:lvl1pPr>
          </a:lstStyle>
          <a:p>
            <a:fld id="{3F36D630-A6FD-4C1E-AE97-3D77FD45B360}" type="datetimeFigureOut">
              <a:rPr kumimoji="1" lang="ja-JP" altLang="en-US" smtClean="0"/>
              <a:t>2020/5/2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420688" y="1241425"/>
            <a:ext cx="595630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26" tIns="45713" rIns="91426" bIns="45713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9768" y="4777195"/>
            <a:ext cx="5438140" cy="3908614"/>
          </a:xfrm>
          <a:prstGeom prst="rect">
            <a:avLst/>
          </a:prstGeom>
        </p:spPr>
        <p:txBody>
          <a:bodyPr vert="horz" lIns="91426" tIns="45713" rIns="91426" bIns="45713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1" y="9428584"/>
            <a:ext cx="2945659" cy="498055"/>
          </a:xfrm>
          <a:prstGeom prst="rect">
            <a:avLst/>
          </a:prstGeom>
        </p:spPr>
        <p:txBody>
          <a:bodyPr vert="horz" lIns="91426" tIns="45713" rIns="91426" bIns="45713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0444" y="9428584"/>
            <a:ext cx="2945659" cy="498055"/>
          </a:xfrm>
          <a:prstGeom prst="rect">
            <a:avLst/>
          </a:prstGeom>
        </p:spPr>
        <p:txBody>
          <a:bodyPr vert="horz" lIns="91426" tIns="45713" rIns="91426" bIns="45713" rtlCol="0" anchor="b"/>
          <a:lstStyle>
            <a:lvl1pPr algn="r">
              <a:defRPr sz="1200"/>
            </a:lvl1pPr>
          </a:lstStyle>
          <a:p>
            <a:fld id="{7F7FA772-E466-485C-B57D-BB00E7F349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1608177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>
              <a:defRPr/>
            </a:pPr>
            <a:fld id="{DCD3D392-4BDE-43B3-9CE9-4A9965A9CF9F}" type="slidenum">
              <a:rPr lang="ja-JP" altLang="en-US" smtClean="0">
                <a:solidFill>
                  <a:srgbClr val="000000"/>
                </a:solidFill>
              </a:rPr>
              <a:pPr>
                <a:defRPr/>
              </a:pPr>
              <a:t>1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88542843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AAE762A-BEF4-4E58-9064-F119342826D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A371FA3F-DAE2-4CF8-8D80-C5A9FB5512D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C76913B-CB5C-4F6B-A4A2-7576AB2349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BB6458-CFD6-4E66-B08D-D774E7D0E9E7}" type="datetimeFigureOut">
              <a:rPr kumimoji="1" lang="ja-JP" altLang="en-US" smtClean="0"/>
              <a:t>2020/5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F676492-67B1-40D2-BED4-D6B95AFA28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DF79910-7237-4E9A-804E-6F838FD675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38764-ADD8-4379-B915-D50B384269C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751885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D07FFF7-EC3D-48C7-8BE4-081A68EA4E6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2DB431FA-673D-44F6-923A-6424E2AF585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6F0ACCE-57DE-4CA1-962F-1A74B1459E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BB6458-CFD6-4E66-B08D-D774E7D0E9E7}" type="datetimeFigureOut">
              <a:rPr kumimoji="1" lang="ja-JP" altLang="en-US" smtClean="0"/>
              <a:t>2020/5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AB256D0-E723-4B24-8243-A2DF1D1C40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957A1DC-7F5B-47A5-9535-BCA84F046D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38764-ADD8-4379-B915-D50B384269C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264582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3DA602B1-559A-4DC0-9105-A9DE351A5F0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ECD156E7-D709-4AE8-A06A-B5D1777AAE1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90ECF86-AB5D-4E21-80A9-90F0EA83C1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BB6458-CFD6-4E66-B08D-D774E7D0E9E7}" type="datetimeFigureOut">
              <a:rPr kumimoji="1" lang="ja-JP" altLang="en-US" smtClean="0"/>
              <a:t>2020/5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EE74D44-680A-4AF3-9441-08B1E8233E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15D1439-3322-4909-920F-71439A3EA8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38764-ADD8-4379-B915-D50B384269C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571808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F243F79-2575-4DEB-BCE4-46060976F8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4A180344-8858-4F81-B883-B885DE9C24D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081F4B0-210B-476E-816A-9B5C015FFB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BB6458-CFD6-4E66-B08D-D774E7D0E9E7}" type="datetimeFigureOut">
              <a:rPr kumimoji="1" lang="ja-JP" altLang="en-US" smtClean="0"/>
              <a:t>2020/5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AEC5CCF-FA45-4204-AF5E-CC61D550BB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0B58BF0-E810-492F-B20C-632818B71F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38764-ADD8-4379-B915-D50B384269C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653786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4EAD9BB-D647-424A-A39D-2B5DCF97C1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D8DF28F1-92DC-4BB4-BA54-C24DB2C8152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ECCEAEF-763A-4945-A324-6BEE81EEB1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BB6458-CFD6-4E66-B08D-D774E7D0E9E7}" type="datetimeFigureOut">
              <a:rPr kumimoji="1" lang="ja-JP" altLang="en-US" smtClean="0"/>
              <a:t>2020/5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861BCEA-F34B-414C-8501-580E20A545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74AE89B-568D-4026-9DB3-2B400B9344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38764-ADD8-4379-B915-D50B384269C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85830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1915C8F-D430-44C7-8E6D-3A113825881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FAAD8283-0D97-4E72-95E1-721ED9E084A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3D2D6E16-4F18-4EAB-BB3D-26838DA4C07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7011CC84-6B76-4B86-9EA1-D64F5AC290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BB6458-CFD6-4E66-B08D-D774E7D0E9E7}" type="datetimeFigureOut">
              <a:rPr kumimoji="1" lang="ja-JP" altLang="en-US" smtClean="0"/>
              <a:t>2020/5/2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EBC8B11-53C3-4921-A3F4-BA8315CE0B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AFD1CAE4-BDF6-4939-8751-D389F6D27A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38764-ADD8-4379-B915-D50B384269C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299026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8393A17-4E2C-477F-AA66-B2BCAED004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1599095F-9EC0-4D3E-AA53-7DC26B3E290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37363EDF-AE82-42BF-A073-576F54B1B3C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67D873A7-8D87-40F2-A0AF-B5A533EB940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726F602E-F904-4380-BBFA-664AFF14AEC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D331BADB-F2DC-4490-B33E-F6DFF75721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BB6458-CFD6-4E66-B08D-D774E7D0E9E7}" type="datetimeFigureOut">
              <a:rPr kumimoji="1" lang="ja-JP" altLang="en-US" smtClean="0"/>
              <a:t>2020/5/27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36091896-6736-4589-8EA0-7A09D57552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9CB52E0B-311F-4FCB-BC5D-7A7CA578B9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38764-ADD8-4379-B915-D50B384269C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419364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7A6986E-EDDC-470A-BC26-456EFCE486C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DD3E6C77-F673-4749-9774-934FEAB1C4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BB6458-CFD6-4E66-B08D-D774E7D0E9E7}" type="datetimeFigureOut">
              <a:rPr kumimoji="1" lang="ja-JP" altLang="en-US" smtClean="0"/>
              <a:t>2020/5/27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12B1C99E-0D66-4252-8224-D8CB4F9C03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AC9306D9-F1E9-4B37-9BA6-0C0BB714E3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38764-ADD8-4379-B915-D50B384269C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146091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99144A88-7AA4-46ED-8719-BB26B419AE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BB6458-CFD6-4E66-B08D-D774E7D0E9E7}" type="datetimeFigureOut">
              <a:rPr kumimoji="1" lang="ja-JP" altLang="en-US" smtClean="0"/>
              <a:t>2020/5/27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5BC86EF4-E13C-40A4-8BFD-34EEDBC827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FD891808-49F3-4D62-8BA9-4241F2DA15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38764-ADD8-4379-B915-D50B384269C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046164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041C508-C875-4447-B2F7-3CDE9A7146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12854C3-7E48-4AE8-B3D2-05836C9AF58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E3FCA51E-DBDC-4A98-80AA-5A8845AB943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557EC4BC-DC33-4A16-9D11-7CBDEF6F21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BB6458-CFD6-4E66-B08D-D774E7D0E9E7}" type="datetimeFigureOut">
              <a:rPr kumimoji="1" lang="ja-JP" altLang="en-US" smtClean="0"/>
              <a:t>2020/5/2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D68219F5-9BC5-4423-A45D-BD61C825AB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7A2AD43-A05A-4440-B584-83FD42E745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38764-ADD8-4379-B915-D50B384269C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56627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DFD13BF-0F34-49C3-AF64-D4B17A1D1E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A5FB7798-6980-44F1-8562-00B80A13C00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C99F5358-8BCB-417F-A036-2D76B2989FB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A15D1071-DEC5-4362-9E9D-E86A8059B6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BB6458-CFD6-4E66-B08D-D774E7D0E9E7}" type="datetimeFigureOut">
              <a:rPr kumimoji="1" lang="ja-JP" altLang="en-US" smtClean="0"/>
              <a:t>2020/5/2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9B36C02-C5D9-4AC5-A3CE-65ACF32EA8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D678B5D-9EB5-4BBA-AAA8-CC7E94E03B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38764-ADD8-4379-B915-D50B384269C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66041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F1EE75F2-4F8A-4FC4-AF46-9AE64E98D4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D2184C40-696F-4FA7-B127-1089C1DF73E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E3E5EA4-9EF9-4B95-A84A-F6647232072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BB6458-CFD6-4E66-B08D-D774E7D0E9E7}" type="datetimeFigureOut">
              <a:rPr kumimoji="1" lang="ja-JP" altLang="en-US" smtClean="0"/>
              <a:t>2020/5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A2080F3-BB35-4415-B93F-73625DAC172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7C3BC3D-FACD-4B1B-A561-013B4DF1A6D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A38764-ADD8-4379-B915-D50B384269C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521949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タイトル 8"/>
          <p:cNvSpPr>
            <a:spLocks noGrp="1"/>
          </p:cNvSpPr>
          <p:nvPr>
            <p:ph type="title"/>
          </p:nvPr>
        </p:nvSpPr>
        <p:spPr>
          <a:xfrm>
            <a:off x="2067735" y="615045"/>
            <a:ext cx="6594360" cy="879724"/>
          </a:xfrm>
        </p:spPr>
        <p:txBody>
          <a:bodyPr>
            <a:norm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 Differences in voriconazole trough concentration (</a:t>
            </a:r>
            <a:r>
              <a:rPr lang="en-US" altLang="ja-JP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altLang="ja-JP" sz="1600" baseline="-25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n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between intravenous and oral administration in patients with sequential therapy in whom the same dosage was used. 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6" name="グラフ 5">
            <a:extLst>
              <a:ext uri="{FF2B5EF4-FFF2-40B4-BE49-F238E27FC236}">
                <a16:creationId xmlns:a16="http://schemas.microsoft.com/office/drawing/2014/main" id="{B82C77FA-A02E-466C-8EC9-118ECAF62153}"/>
              </a:ext>
            </a:extLst>
          </p:cNvPr>
          <p:cNvGraphicFramePr>
            <a:graphicFrameLocks/>
          </p:cNvGraphicFramePr>
          <p:nvPr/>
        </p:nvGraphicFramePr>
        <p:xfrm>
          <a:off x="1738254" y="1494769"/>
          <a:ext cx="6923841" cy="484437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7565569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25</TotalTime>
  <Words>38</Words>
  <Application>Microsoft Office PowerPoint</Application>
  <PresentationFormat>ワイド画面</PresentationFormat>
  <Paragraphs>3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Supplementary Figure 1. Differences in voriconazole trough concentration (Cmin) between intravenous and oral administration in patients with sequential therapy in whom the same dosage was used. 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able 1. Patient demographic and clinical characteristics.</dc:title>
  <dc:creator>ueda</dc:creator>
  <cp:lastModifiedBy>ueda</cp:lastModifiedBy>
  <cp:revision>20</cp:revision>
  <cp:lastPrinted>2020-05-25T11:39:15Z</cp:lastPrinted>
  <dcterms:created xsi:type="dcterms:W3CDTF">2020-03-04T08:39:43Z</dcterms:created>
  <dcterms:modified xsi:type="dcterms:W3CDTF">2020-05-27T10:50:45Z</dcterms:modified>
</cp:coreProperties>
</file>